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588125" cy="4160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9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3516" y="680952"/>
            <a:ext cx="4941094" cy="1448588"/>
          </a:xfrm>
        </p:spPr>
        <p:txBody>
          <a:bodyPr anchor="b"/>
          <a:lstStyle>
            <a:lvl1pPr algn="ctr">
              <a:defRPr sz="32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3516" y="2185404"/>
            <a:ext cx="4941094" cy="1004572"/>
          </a:xfrm>
        </p:spPr>
        <p:txBody>
          <a:bodyPr/>
          <a:lstStyle>
            <a:lvl1pPr marL="0" indent="0" algn="ctr">
              <a:buNone/>
              <a:defRPr sz="1297"/>
            </a:lvl1pPr>
            <a:lvl2pPr marL="247071" indent="0" algn="ctr">
              <a:buNone/>
              <a:defRPr sz="1081"/>
            </a:lvl2pPr>
            <a:lvl3pPr marL="494142" indent="0" algn="ctr">
              <a:buNone/>
              <a:defRPr sz="973"/>
            </a:lvl3pPr>
            <a:lvl4pPr marL="741213" indent="0" algn="ctr">
              <a:buNone/>
              <a:defRPr sz="865"/>
            </a:lvl4pPr>
            <a:lvl5pPr marL="988284" indent="0" algn="ctr">
              <a:buNone/>
              <a:defRPr sz="865"/>
            </a:lvl5pPr>
            <a:lvl6pPr marL="1235354" indent="0" algn="ctr">
              <a:buNone/>
              <a:defRPr sz="865"/>
            </a:lvl6pPr>
            <a:lvl7pPr marL="1482425" indent="0" algn="ctr">
              <a:buNone/>
              <a:defRPr sz="865"/>
            </a:lvl7pPr>
            <a:lvl8pPr marL="1729496" indent="0" algn="ctr">
              <a:buNone/>
              <a:defRPr sz="865"/>
            </a:lvl8pPr>
            <a:lvl9pPr marL="1976567" indent="0" algn="ctr">
              <a:buNone/>
              <a:defRPr sz="86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880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1559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14627" y="221526"/>
            <a:ext cx="1420564" cy="352611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2933" y="221526"/>
            <a:ext cx="4179342" cy="352611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0145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384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9502" y="1037320"/>
            <a:ext cx="5682258" cy="1730793"/>
          </a:xfrm>
        </p:spPr>
        <p:txBody>
          <a:bodyPr anchor="b"/>
          <a:lstStyle>
            <a:lvl1pPr>
              <a:defRPr sz="32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9502" y="2784487"/>
            <a:ext cx="5682258" cy="910183"/>
          </a:xfrm>
        </p:spPr>
        <p:txBody>
          <a:bodyPr/>
          <a:lstStyle>
            <a:lvl1pPr marL="0" indent="0">
              <a:buNone/>
              <a:defRPr sz="1297">
                <a:solidFill>
                  <a:schemeClr val="tx1">
                    <a:tint val="75000"/>
                  </a:schemeClr>
                </a:solidFill>
              </a:defRPr>
            </a:lvl1pPr>
            <a:lvl2pPr marL="247071" indent="0">
              <a:buNone/>
              <a:defRPr sz="1081">
                <a:solidFill>
                  <a:schemeClr val="tx1">
                    <a:tint val="75000"/>
                  </a:schemeClr>
                </a:solidFill>
              </a:defRPr>
            </a:lvl2pPr>
            <a:lvl3pPr marL="494142" indent="0">
              <a:buNone/>
              <a:defRPr sz="973">
                <a:solidFill>
                  <a:schemeClr val="tx1">
                    <a:tint val="75000"/>
                  </a:schemeClr>
                </a:solidFill>
              </a:defRPr>
            </a:lvl3pPr>
            <a:lvl4pPr marL="741213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4pPr>
            <a:lvl5pPr marL="988284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5pPr>
            <a:lvl6pPr marL="1235354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6pPr>
            <a:lvl7pPr marL="1482425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7pPr>
            <a:lvl8pPr marL="1729496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8pPr>
            <a:lvl9pPr marL="1976567" indent="0">
              <a:buNone/>
              <a:defRPr sz="86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8636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2934" y="1107631"/>
            <a:ext cx="2799953" cy="26400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35238" y="1107631"/>
            <a:ext cx="2799953" cy="26400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4475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21527"/>
            <a:ext cx="5682258" cy="8042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3792" y="1019984"/>
            <a:ext cx="2787085" cy="499878"/>
          </a:xfrm>
        </p:spPr>
        <p:txBody>
          <a:bodyPr anchor="b"/>
          <a:lstStyle>
            <a:lvl1pPr marL="0" indent="0">
              <a:buNone/>
              <a:defRPr sz="1297" b="1"/>
            </a:lvl1pPr>
            <a:lvl2pPr marL="247071" indent="0">
              <a:buNone/>
              <a:defRPr sz="1081" b="1"/>
            </a:lvl2pPr>
            <a:lvl3pPr marL="494142" indent="0">
              <a:buNone/>
              <a:defRPr sz="973" b="1"/>
            </a:lvl3pPr>
            <a:lvl4pPr marL="741213" indent="0">
              <a:buNone/>
              <a:defRPr sz="865" b="1"/>
            </a:lvl4pPr>
            <a:lvl5pPr marL="988284" indent="0">
              <a:buNone/>
              <a:defRPr sz="865" b="1"/>
            </a:lvl5pPr>
            <a:lvl6pPr marL="1235354" indent="0">
              <a:buNone/>
              <a:defRPr sz="865" b="1"/>
            </a:lvl6pPr>
            <a:lvl7pPr marL="1482425" indent="0">
              <a:buNone/>
              <a:defRPr sz="865" b="1"/>
            </a:lvl7pPr>
            <a:lvl8pPr marL="1729496" indent="0">
              <a:buNone/>
              <a:defRPr sz="865" b="1"/>
            </a:lvl8pPr>
            <a:lvl9pPr marL="1976567" indent="0">
              <a:buNone/>
              <a:defRPr sz="8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3792" y="1519861"/>
            <a:ext cx="2787085" cy="22354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35238" y="1019984"/>
            <a:ext cx="2800811" cy="499878"/>
          </a:xfrm>
        </p:spPr>
        <p:txBody>
          <a:bodyPr anchor="b"/>
          <a:lstStyle>
            <a:lvl1pPr marL="0" indent="0">
              <a:buNone/>
              <a:defRPr sz="1297" b="1"/>
            </a:lvl1pPr>
            <a:lvl2pPr marL="247071" indent="0">
              <a:buNone/>
              <a:defRPr sz="1081" b="1"/>
            </a:lvl2pPr>
            <a:lvl3pPr marL="494142" indent="0">
              <a:buNone/>
              <a:defRPr sz="973" b="1"/>
            </a:lvl3pPr>
            <a:lvl4pPr marL="741213" indent="0">
              <a:buNone/>
              <a:defRPr sz="865" b="1"/>
            </a:lvl4pPr>
            <a:lvl5pPr marL="988284" indent="0">
              <a:buNone/>
              <a:defRPr sz="865" b="1"/>
            </a:lvl5pPr>
            <a:lvl6pPr marL="1235354" indent="0">
              <a:buNone/>
              <a:defRPr sz="865" b="1"/>
            </a:lvl6pPr>
            <a:lvl7pPr marL="1482425" indent="0">
              <a:buNone/>
              <a:defRPr sz="865" b="1"/>
            </a:lvl7pPr>
            <a:lvl8pPr marL="1729496" indent="0">
              <a:buNone/>
              <a:defRPr sz="865" b="1"/>
            </a:lvl8pPr>
            <a:lvl9pPr marL="1976567" indent="0">
              <a:buNone/>
              <a:defRPr sz="8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35238" y="1519861"/>
            <a:ext cx="2800811" cy="22354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95797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837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28103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77389"/>
            <a:ext cx="2124842" cy="970862"/>
          </a:xfrm>
        </p:spPr>
        <p:txBody>
          <a:bodyPr anchor="b"/>
          <a:lstStyle>
            <a:lvl1pPr>
              <a:defRPr sz="172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0811" y="599084"/>
            <a:ext cx="3335238" cy="2956892"/>
          </a:xfrm>
        </p:spPr>
        <p:txBody>
          <a:bodyPr/>
          <a:lstStyle>
            <a:lvl1pPr>
              <a:defRPr sz="1729"/>
            </a:lvl1pPr>
            <a:lvl2pPr>
              <a:defRPr sz="1513"/>
            </a:lvl2pPr>
            <a:lvl3pPr>
              <a:defRPr sz="1297"/>
            </a:lvl3pPr>
            <a:lvl4pPr>
              <a:defRPr sz="1081"/>
            </a:lvl4pPr>
            <a:lvl5pPr>
              <a:defRPr sz="1081"/>
            </a:lvl5pPr>
            <a:lvl6pPr>
              <a:defRPr sz="1081"/>
            </a:lvl6pPr>
            <a:lvl7pPr>
              <a:defRPr sz="1081"/>
            </a:lvl7pPr>
            <a:lvl8pPr>
              <a:defRPr sz="1081"/>
            </a:lvl8pPr>
            <a:lvl9pPr>
              <a:defRPr sz="108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1248251"/>
            <a:ext cx="2124842" cy="2312540"/>
          </a:xfrm>
        </p:spPr>
        <p:txBody>
          <a:bodyPr/>
          <a:lstStyle>
            <a:lvl1pPr marL="0" indent="0">
              <a:buNone/>
              <a:defRPr sz="865"/>
            </a:lvl1pPr>
            <a:lvl2pPr marL="247071" indent="0">
              <a:buNone/>
              <a:defRPr sz="757"/>
            </a:lvl2pPr>
            <a:lvl3pPr marL="494142" indent="0">
              <a:buNone/>
              <a:defRPr sz="648"/>
            </a:lvl3pPr>
            <a:lvl4pPr marL="741213" indent="0">
              <a:buNone/>
              <a:defRPr sz="540"/>
            </a:lvl4pPr>
            <a:lvl5pPr marL="988284" indent="0">
              <a:buNone/>
              <a:defRPr sz="540"/>
            </a:lvl5pPr>
            <a:lvl6pPr marL="1235354" indent="0">
              <a:buNone/>
              <a:defRPr sz="540"/>
            </a:lvl6pPr>
            <a:lvl7pPr marL="1482425" indent="0">
              <a:buNone/>
              <a:defRPr sz="540"/>
            </a:lvl7pPr>
            <a:lvl8pPr marL="1729496" indent="0">
              <a:buNone/>
              <a:defRPr sz="540"/>
            </a:lvl8pPr>
            <a:lvl9pPr marL="1976567" indent="0">
              <a:buNone/>
              <a:defRPr sz="5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2902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792" y="277389"/>
            <a:ext cx="2124842" cy="970862"/>
          </a:xfrm>
        </p:spPr>
        <p:txBody>
          <a:bodyPr anchor="b"/>
          <a:lstStyle>
            <a:lvl1pPr>
              <a:defRPr sz="172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00811" y="599084"/>
            <a:ext cx="3335238" cy="2956892"/>
          </a:xfrm>
        </p:spPr>
        <p:txBody>
          <a:bodyPr anchor="t"/>
          <a:lstStyle>
            <a:lvl1pPr marL="0" indent="0">
              <a:buNone/>
              <a:defRPr sz="1729"/>
            </a:lvl1pPr>
            <a:lvl2pPr marL="247071" indent="0">
              <a:buNone/>
              <a:defRPr sz="1513"/>
            </a:lvl2pPr>
            <a:lvl3pPr marL="494142" indent="0">
              <a:buNone/>
              <a:defRPr sz="1297"/>
            </a:lvl3pPr>
            <a:lvl4pPr marL="741213" indent="0">
              <a:buNone/>
              <a:defRPr sz="1081"/>
            </a:lvl4pPr>
            <a:lvl5pPr marL="988284" indent="0">
              <a:buNone/>
              <a:defRPr sz="1081"/>
            </a:lvl5pPr>
            <a:lvl6pPr marL="1235354" indent="0">
              <a:buNone/>
              <a:defRPr sz="1081"/>
            </a:lvl6pPr>
            <a:lvl7pPr marL="1482425" indent="0">
              <a:buNone/>
              <a:defRPr sz="1081"/>
            </a:lvl7pPr>
            <a:lvl8pPr marL="1729496" indent="0">
              <a:buNone/>
              <a:defRPr sz="1081"/>
            </a:lvl8pPr>
            <a:lvl9pPr marL="1976567" indent="0">
              <a:buNone/>
              <a:defRPr sz="108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3792" y="1248251"/>
            <a:ext cx="2124842" cy="2312540"/>
          </a:xfrm>
        </p:spPr>
        <p:txBody>
          <a:bodyPr/>
          <a:lstStyle>
            <a:lvl1pPr marL="0" indent="0">
              <a:buNone/>
              <a:defRPr sz="865"/>
            </a:lvl1pPr>
            <a:lvl2pPr marL="247071" indent="0">
              <a:buNone/>
              <a:defRPr sz="757"/>
            </a:lvl2pPr>
            <a:lvl3pPr marL="494142" indent="0">
              <a:buNone/>
              <a:defRPr sz="648"/>
            </a:lvl3pPr>
            <a:lvl4pPr marL="741213" indent="0">
              <a:buNone/>
              <a:defRPr sz="540"/>
            </a:lvl4pPr>
            <a:lvl5pPr marL="988284" indent="0">
              <a:buNone/>
              <a:defRPr sz="540"/>
            </a:lvl5pPr>
            <a:lvl6pPr marL="1235354" indent="0">
              <a:buNone/>
              <a:defRPr sz="540"/>
            </a:lvl6pPr>
            <a:lvl7pPr marL="1482425" indent="0">
              <a:buNone/>
              <a:defRPr sz="540"/>
            </a:lvl7pPr>
            <a:lvl8pPr marL="1729496" indent="0">
              <a:buNone/>
              <a:defRPr sz="540"/>
            </a:lvl8pPr>
            <a:lvl9pPr marL="1976567" indent="0">
              <a:buNone/>
              <a:defRPr sz="5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897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2934" y="221527"/>
            <a:ext cx="5682258" cy="8042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934" y="1107631"/>
            <a:ext cx="5682258" cy="26400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2934" y="3856481"/>
            <a:ext cx="1482328" cy="2215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EDB1F-288F-4A0F-8515-D265C91E99E2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2317" y="3856481"/>
            <a:ext cx="2223492" cy="2215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2863" y="3856481"/>
            <a:ext cx="1482328" cy="2215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F8E4B-CFE6-425C-9606-282379F412F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9534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94142" rtl="0" eaLnBrk="1" latinLnBrk="0" hangingPunct="1">
        <a:lnSpc>
          <a:spcPct val="90000"/>
        </a:lnSpc>
        <a:spcBef>
          <a:spcPct val="0"/>
        </a:spcBef>
        <a:buNone/>
        <a:defRPr sz="2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3535" indent="-123535" algn="l" defTabSz="494142" rtl="0" eaLnBrk="1" latinLnBrk="0" hangingPunct="1">
        <a:lnSpc>
          <a:spcPct val="90000"/>
        </a:lnSpc>
        <a:spcBef>
          <a:spcPts val="540"/>
        </a:spcBef>
        <a:buFont typeface="Arial" panose="020B0604020202020204" pitchFamily="34" charset="0"/>
        <a:buChar char="•"/>
        <a:defRPr sz="1513" kern="1200">
          <a:solidFill>
            <a:schemeClr val="tx1"/>
          </a:solidFill>
          <a:latin typeface="+mn-lt"/>
          <a:ea typeface="+mn-ea"/>
          <a:cs typeface="+mn-cs"/>
        </a:defRPr>
      </a:lvl1pPr>
      <a:lvl2pPr marL="370606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1297" kern="1200">
          <a:solidFill>
            <a:schemeClr val="tx1"/>
          </a:solidFill>
          <a:latin typeface="+mn-lt"/>
          <a:ea typeface="+mn-ea"/>
          <a:cs typeface="+mn-cs"/>
        </a:defRPr>
      </a:lvl2pPr>
      <a:lvl3pPr marL="617677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1081" kern="1200">
          <a:solidFill>
            <a:schemeClr val="tx1"/>
          </a:solidFill>
          <a:latin typeface="+mn-lt"/>
          <a:ea typeface="+mn-ea"/>
          <a:cs typeface="+mn-cs"/>
        </a:defRPr>
      </a:lvl3pPr>
      <a:lvl4pPr marL="864748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4pPr>
      <a:lvl5pPr marL="1111819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5pPr>
      <a:lvl6pPr marL="1358890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6pPr>
      <a:lvl7pPr marL="1605961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7pPr>
      <a:lvl8pPr marL="1853032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8pPr>
      <a:lvl9pPr marL="2100102" indent="-123535" algn="l" defTabSz="494142" rtl="0" eaLnBrk="1" latinLnBrk="0" hangingPunct="1">
        <a:lnSpc>
          <a:spcPct val="90000"/>
        </a:lnSpc>
        <a:spcBef>
          <a:spcPts val="270"/>
        </a:spcBef>
        <a:buFont typeface="Arial" panose="020B0604020202020204" pitchFamily="34" charset="0"/>
        <a:buChar char="•"/>
        <a:defRPr sz="9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1pPr>
      <a:lvl2pPr marL="247071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2pPr>
      <a:lvl3pPr marL="494142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3pPr>
      <a:lvl4pPr marL="741213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4pPr>
      <a:lvl5pPr marL="988284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5pPr>
      <a:lvl6pPr marL="1235354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6pPr>
      <a:lvl7pPr marL="1482425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7pPr>
      <a:lvl8pPr marL="1729496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8pPr>
      <a:lvl9pPr marL="1976567" algn="l" defTabSz="494142" rtl="0" eaLnBrk="1" latinLnBrk="0" hangingPunct="1">
        <a:defRPr sz="9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D8262FC-C2FF-4812-B74D-2AA0EB35FFE0}"/>
              </a:ext>
            </a:extLst>
          </p:cNvPr>
          <p:cNvGrpSpPr/>
          <p:nvPr/>
        </p:nvGrpSpPr>
        <p:grpSpPr>
          <a:xfrm>
            <a:off x="64482" y="4037"/>
            <a:ext cx="6596084" cy="4160198"/>
            <a:chOff x="0" y="-1825"/>
            <a:chExt cx="6648891" cy="4160198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09192EA7-C88D-406A-AC27-8D78E5EE1F57}"/>
                </a:ext>
              </a:extLst>
            </p:cNvPr>
            <p:cNvSpPr/>
            <p:nvPr/>
          </p:nvSpPr>
          <p:spPr>
            <a:xfrm>
              <a:off x="6338" y="-1"/>
              <a:ext cx="6560534" cy="4114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" name="Google Shape;1180;p16" descr="Scatter chart&#10;&#10;Description automatically generated">
              <a:extLst>
                <a:ext uri="{FF2B5EF4-FFF2-40B4-BE49-F238E27FC236}">
                  <a16:creationId xmlns:a16="http://schemas.microsoft.com/office/drawing/2014/main" id="{698B0C47-EC64-449E-9F6E-BDF2C36CE919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l="5430" t="3084" b="5402"/>
            <a:stretch/>
          </p:blipFill>
          <p:spPr>
            <a:xfrm>
              <a:off x="296869" y="531345"/>
              <a:ext cx="2609095" cy="280082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Google Shape;1181;p16">
              <a:extLst>
                <a:ext uri="{FF2B5EF4-FFF2-40B4-BE49-F238E27FC236}">
                  <a16:creationId xmlns:a16="http://schemas.microsoft.com/office/drawing/2014/main" id="{46EAF7A7-F053-4A01-B92F-B71A19CF7D4E}"/>
                </a:ext>
              </a:extLst>
            </p:cNvPr>
            <p:cNvSpPr txBox="1"/>
            <p:nvPr/>
          </p:nvSpPr>
          <p:spPr>
            <a:xfrm>
              <a:off x="0" y="202"/>
              <a:ext cx="151062" cy="230380"/>
            </a:xfrm>
            <a:prstGeom prst="rect">
              <a:avLst/>
            </a:prstGeom>
            <a:solidFill>
              <a:schemeClr val="lt1"/>
            </a:solidFill>
            <a:ln w="9525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de-DE" sz="8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Google Shape;1185;p16">
              <a:extLst>
                <a:ext uri="{FF2B5EF4-FFF2-40B4-BE49-F238E27FC236}">
                  <a16:creationId xmlns:a16="http://schemas.microsoft.com/office/drawing/2014/main" id="{CF027133-167D-4E36-B1D3-BBBCEA4EFA14}"/>
                </a:ext>
              </a:extLst>
            </p:cNvPr>
            <p:cNvSpPr/>
            <p:nvPr/>
          </p:nvSpPr>
          <p:spPr>
            <a:xfrm>
              <a:off x="2770532" y="1629169"/>
              <a:ext cx="35330" cy="31874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ctr" anchorCtr="0">
              <a:noAutofit/>
            </a:bodyPr>
            <a:lstStyle/>
            <a:p>
              <a:pPr algn="ctr"/>
              <a:endParaRPr sz="500">
                <a:solidFill>
                  <a:schemeClr val="l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Google Shape;1186;p16">
              <a:extLst>
                <a:ext uri="{FF2B5EF4-FFF2-40B4-BE49-F238E27FC236}">
                  <a16:creationId xmlns:a16="http://schemas.microsoft.com/office/drawing/2014/main" id="{10F1EE8F-B499-4DA2-81A2-0710EF1B4376}"/>
                </a:ext>
              </a:extLst>
            </p:cNvPr>
            <p:cNvSpPr/>
            <p:nvPr/>
          </p:nvSpPr>
          <p:spPr>
            <a:xfrm>
              <a:off x="2346914" y="1614179"/>
              <a:ext cx="18297" cy="43674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ctr" anchorCtr="0">
              <a:noAutofit/>
            </a:bodyPr>
            <a:lstStyle/>
            <a:p>
              <a:pPr algn="ctr"/>
              <a:endParaRPr sz="500">
                <a:solidFill>
                  <a:schemeClr val="l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Google Shape;1189;p16">
              <a:extLst>
                <a:ext uri="{FF2B5EF4-FFF2-40B4-BE49-F238E27FC236}">
                  <a16:creationId xmlns:a16="http://schemas.microsoft.com/office/drawing/2014/main" id="{1CF65F6A-0DFC-4F52-AFB8-B7DA070DDBCD}"/>
                </a:ext>
              </a:extLst>
            </p:cNvPr>
            <p:cNvSpPr txBox="1"/>
            <p:nvPr/>
          </p:nvSpPr>
          <p:spPr>
            <a:xfrm>
              <a:off x="1987460" y="3552473"/>
              <a:ext cx="1298882" cy="21499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eralized linear model </a:t>
              </a:r>
              <a:endParaRPr sz="7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Google Shape;1192;p16">
              <a:extLst>
                <a:ext uri="{FF2B5EF4-FFF2-40B4-BE49-F238E27FC236}">
                  <a16:creationId xmlns:a16="http://schemas.microsoft.com/office/drawing/2014/main" id="{AEEB2D3B-7513-4419-A89E-A72D9B6CC4A7}"/>
                </a:ext>
              </a:extLst>
            </p:cNvPr>
            <p:cNvSpPr/>
            <p:nvPr/>
          </p:nvSpPr>
          <p:spPr>
            <a:xfrm>
              <a:off x="2178327" y="1342380"/>
              <a:ext cx="61468" cy="60885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ctr" anchorCtr="0">
              <a:noAutofit/>
            </a:bodyPr>
            <a:lstStyle/>
            <a:p>
              <a:pPr algn="ctr"/>
              <a:endParaRPr sz="500">
                <a:solidFill>
                  <a:schemeClr val="l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Google Shape;1193;p16">
              <a:extLst>
                <a:ext uri="{FF2B5EF4-FFF2-40B4-BE49-F238E27FC236}">
                  <a16:creationId xmlns:a16="http://schemas.microsoft.com/office/drawing/2014/main" id="{B69C9D54-DA3A-40D7-A81F-892D47C64075}"/>
                </a:ext>
              </a:extLst>
            </p:cNvPr>
            <p:cNvSpPr txBox="1"/>
            <p:nvPr/>
          </p:nvSpPr>
          <p:spPr>
            <a:xfrm rot="16200000">
              <a:off x="-413560" y="1823618"/>
              <a:ext cx="1076264" cy="21499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700" b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b="1" i="1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b="1" i="1" baseline="-250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j</a:t>
              </a:r>
              <a:r>
                <a:rPr lang="en-US" sz="700" b="1" i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700" b="1" i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r>
                <a:rPr lang="en-US" sz="700" b="1" i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Google Shape;1196;p16">
              <a:extLst>
                <a:ext uri="{FF2B5EF4-FFF2-40B4-BE49-F238E27FC236}">
                  <a16:creationId xmlns:a16="http://schemas.microsoft.com/office/drawing/2014/main" id="{78B8B622-9063-4F50-AF24-A2A454272AF9}"/>
                </a:ext>
              </a:extLst>
            </p:cNvPr>
            <p:cNvSpPr/>
            <p:nvPr/>
          </p:nvSpPr>
          <p:spPr>
            <a:xfrm>
              <a:off x="2148684" y="1342380"/>
              <a:ext cx="42734" cy="60885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ctr" anchorCtr="0">
              <a:noAutofit/>
            </a:bodyPr>
            <a:lstStyle/>
            <a:p>
              <a:pPr algn="ctr"/>
              <a:endParaRPr sz="500">
                <a:solidFill>
                  <a:schemeClr val="l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Google Shape;1198;p16">
              <a:extLst>
                <a:ext uri="{FF2B5EF4-FFF2-40B4-BE49-F238E27FC236}">
                  <a16:creationId xmlns:a16="http://schemas.microsoft.com/office/drawing/2014/main" id="{AD5303BB-5E9A-4325-A245-D7F0185DCEFC}"/>
                </a:ext>
              </a:extLst>
            </p:cNvPr>
            <p:cNvSpPr txBox="1"/>
            <p:nvPr/>
          </p:nvSpPr>
          <p:spPr>
            <a:xfrm>
              <a:off x="664194" y="272698"/>
              <a:ext cx="990713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reased </a:t>
              </a:r>
              <a:r>
                <a:rPr lang="en-US" sz="500" baseline="30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 in WT cluster</a:t>
              </a:r>
              <a:endParaRPr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Google Shape;1199;p16">
              <a:extLst>
                <a:ext uri="{FF2B5EF4-FFF2-40B4-BE49-F238E27FC236}">
                  <a16:creationId xmlns:a16="http://schemas.microsoft.com/office/drawing/2014/main" id="{26FD6972-B243-4990-8A6A-A989C92BD460}"/>
                </a:ext>
              </a:extLst>
            </p:cNvPr>
            <p:cNvSpPr txBox="1"/>
            <p:nvPr/>
          </p:nvSpPr>
          <p:spPr>
            <a:xfrm>
              <a:off x="1485478" y="269704"/>
              <a:ext cx="1080081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reased </a:t>
              </a:r>
              <a:r>
                <a:rPr lang="en-US" sz="500" baseline="30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 in HD cluster</a:t>
              </a:r>
              <a:endParaRPr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Google Shape;1200;p16">
              <a:extLst>
                <a:ext uri="{FF2B5EF4-FFF2-40B4-BE49-F238E27FC236}">
                  <a16:creationId xmlns:a16="http://schemas.microsoft.com/office/drawing/2014/main" id="{8FAA4A0F-B5F5-4121-B663-71C59FE497BD}"/>
                </a:ext>
              </a:extLst>
            </p:cNvPr>
            <p:cNvCxnSpPr/>
            <p:nvPr/>
          </p:nvCxnSpPr>
          <p:spPr>
            <a:xfrm>
              <a:off x="1648415" y="466041"/>
              <a:ext cx="76314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17" name="Google Shape;1201;p16">
              <a:extLst>
                <a:ext uri="{FF2B5EF4-FFF2-40B4-BE49-F238E27FC236}">
                  <a16:creationId xmlns:a16="http://schemas.microsoft.com/office/drawing/2014/main" id="{CEEEAD4E-5CD7-44B7-99DC-FAF4A21BFC84}"/>
                </a:ext>
              </a:extLst>
            </p:cNvPr>
            <p:cNvSpPr/>
            <p:nvPr/>
          </p:nvSpPr>
          <p:spPr>
            <a:xfrm>
              <a:off x="2466326" y="1434849"/>
              <a:ext cx="79317" cy="78117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106260" tIns="53116" rIns="106260" bIns="53116" anchor="ctr" anchorCtr="0">
              <a:noAutofit/>
            </a:bodyPr>
            <a:lstStyle/>
            <a:p>
              <a:pPr algn="ctr"/>
              <a:endParaRPr sz="500">
                <a:solidFill>
                  <a:schemeClr val="l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Google Shape;1089;p14">
              <a:extLst>
                <a:ext uri="{FF2B5EF4-FFF2-40B4-BE49-F238E27FC236}">
                  <a16:creationId xmlns:a16="http://schemas.microsoft.com/office/drawing/2014/main" id="{816FAACC-474A-44F7-9186-3C52D8553703}"/>
                </a:ext>
              </a:extLst>
            </p:cNvPr>
            <p:cNvSpPr txBox="1"/>
            <p:nvPr/>
          </p:nvSpPr>
          <p:spPr>
            <a:xfrm>
              <a:off x="1143199" y="3405531"/>
              <a:ext cx="916434" cy="21499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hen‘s d value</a:t>
              </a:r>
              <a:endParaRPr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5591CE29-CAEE-46FD-8851-A0C043AD62F8}"/>
                </a:ext>
              </a:extLst>
            </p:cNvPr>
            <p:cNvGrpSpPr/>
            <p:nvPr/>
          </p:nvGrpSpPr>
          <p:grpSpPr>
            <a:xfrm>
              <a:off x="2295411" y="995708"/>
              <a:ext cx="1039069" cy="1279734"/>
              <a:chOff x="9866510" y="5603290"/>
              <a:chExt cx="2873407" cy="2973028"/>
            </a:xfrm>
          </p:grpSpPr>
          <p:pic>
            <p:nvPicPr>
              <p:cNvPr id="37" name="Google Shape;1084;p14" descr="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7932DB94-82BF-46A4-8D70-078099A32775}"/>
                  </a:ext>
                </a:extLst>
              </p:cNvPr>
              <p:cNvPicPr preferRelativeResize="0"/>
              <p:nvPr/>
            </p:nvPicPr>
            <p:blipFill rotWithShape="1">
              <a:blip r:embed="rId3">
                <a:alphaModFix/>
              </a:blip>
              <a:srcRect l="67227" t="28882" r="29579" b="25727"/>
              <a:stretch/>
            </p:blipFill>
            <p:spPr>
              <a:xfrm>
                <a:off x="10286344" y="6001083"/>
                <a:ext cx="274268" cy="226056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8" name="Google Shape;1088;p14">
                <a:extLst>
                  <a:ext uri="{FF2B5EF4-FFF2-40B4-BE49-F238E27FC236}">
                    <a16:creationId xmlns:a16="http://schemas.microsoft.com/office/drawing/2014/main" id="{C63BC48B-C1F4-4133-8BEA-F6AC3C478552}"/>
                  </a:ext>
                </a:extLst>
              </p:cNvPr>
              <p:cNvSpPr txBox="1"/>
              <p:nvPr/>
            </p:nvSpPr>
            <p:spPr>
              <a:xfrm>
                <a:off x="10333587" y="5913941"/>
                <a:ext cx="2306646" cy="26623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Axonal fatty ac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Axonal lip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Unknown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Synaptic lip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Myelin lip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Mitochondrial lip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Astrocyte lipid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Neuronal cell body lipids </a:t>
                </a:r>
                <a:endParaRPr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4A1715A-7145-49DA-B13F-D0918A192CF4}"/>
                  </a:ext>
                </a:extLst>
              </p:cNvPr>
              <p:cNvSpPr txBox="1"/>
              <p:nvPr/>
            </p:nvSpPr>
            <p:spPr>
              <a:xfrm>
                <a:off x="9866510" y="5603290"/>
                <a:ext cx="2873407" cy="4647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atomical location</a:t>
                </a:r>
                <a:endParaRPr lang="en-AU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" name="Google Shape;1233;p16">
              <a:extLst>
                <a:ext uri="{FF2B5EF4-FFF2-40B4-BE49-F238E27FC236}">
                  <a16:creationId xmlns:a16="http://schemas.microsoft.com/office/drawing/2014/main" id="{916D91CE-DE19-4A56-A301-BF8D9F6CD20E}"/>
                </a:ext>
              </a:extLst>
            </p:cNvPr>
            <p:cNvSpPr txBox="1"/>
            <p:nvPr/>
          </p:nvSpPr>
          <p:spPr>
            <a:xfrm>
              <a:off x="50004" y="3289365"/>
              <a:ext cx="2857651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- 20                            -10                              0                               10                           20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Google Shape;1222;p16">
              <a:extLst>
                <a:ext uri="{FF2B5EF4-FFF2-40B4-BE49-F238E27FC236}">
                  <a16:creationId xmlns:a16="http://schemas.microsoft.com/office/drawing/2014/main" id="{F7466EEB-6B9D-438F-8229-91B74D6BD900}"/>
                </a:ext>
              </a:extLst>
            </p:cNvPr>
            <p:cNvSpPr/>
            <p:nvPr/>
          </p:nvSpPr>
          <p:spPr>
            <a:xfrm>
              <a:off x="171463" y="3098816"/>
              <a:ext cx="197877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Google Shape;1222;p16">
              <a:extLst>
                <a:ext uri="{FF2B5EF4-FFF2-40B4-BE49-F238E27FC236}">
                  <a16:creationId xmlns:a16="http://schemas.microsoft.com/office/drawing/2014/main" id="{5767975A-549F-4783-B4B6-526FFE71A692}"/>
                </a:ext>
              </a:extLst>
            </p:cNvPr>
            <p:cNvSpPr/>
            <p:nvPr/>
          </p:nvSpPr>
          <p:spPr>
            <a:xfrm>
              <a:off x="174226" y="2442315"/>
              <a:ext cx="197877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Google Shape;1222;p16">
              <a:extLst>
                <a:ext uri="{FF2B5EF4-FFF2-40B4-BE49-F238E27FC236}">
                  <a16:creationId xmlns:a16="http://schemas.microsoft.com/office/drawing/2014/main" id="{67C21E58-247F-441B-8E94-E3E5F208BE96}"/>
                </a:ext>
              </a:extLst>
            </p:cNvPr>
            <p:cNvSpPr/>
            <p:nvPr/>
          </p:nvSpPr>
          <p:spPr>
            <a:xfrm>
              <a:off x="171463" y="1779464"/>
              <a:ext cx="197877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Google Shape;1222;p16">
              <a:extLst>
                <a:ext uri="{FF2B5EF4-FFF2-40B4-BE49-F238E27FC236}">
                  <a16:creationId xmlns:a16="http://schemas.microsoft.com/office/drawing/2014/main" id="{754BD24B-96AB-421F-84C7-533C4DEC3433}"/>
                </a:ext>
              </a:extLst>
            </p:cNvPr>
            <p:cNvSpPr/>
            <p:nvPr/>
          </p:nvSpPr>
          <p:spPr>
            <a:xfrm>
              <a:off x="171463" y="1110262"/>
              <a:ext cx="197877" cy="18421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180E5C3-5209-408C-941B-6163017E2648}"/>
                </a:ext>
              </a:extLst>
            </p:cNvPr>
            <p:cNvSpPr txBox="1"/>
            <p:nvPr/>
          </p:nvSpPr>
          <p:spPr>
            <a:xfrm>
              <a:off x="5688396" y="3958318"/>
              <a:ext cx="89479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isher exact test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Picture 25" descr="Timeline&#10;&#10;Description automatically generated">
              <a:extLst>
                <a:ext uri="{FF2B5EF4-FFF2-40B4-BE49-F238E27FC236}">
                  <a16:creationId xmlns:a16="http://schemas.microsoft.com/office/drawing/2014/main" id="{E4CCBFE6-70C0-4D51-8940-E673F4002C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91" r="24531" b="6377"/>
            <a:stretch/>
          </p:blipFill>
          <p:spPr>
            <a:xfrm>
              <a:off x="4467225" y="0"/>
              <a:ext cx="1750400" cy="3600451"/>
            </a:xfrm>
            <a:prstGeom prst="rect">
              <a:avLst/>
            </a:prstGeom>
          </p:spPr>
        </p:pic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99EAEE72-C11C-4AA4-BFA9-A0D2539A4919}"/>
                </a:ext>
              </a:extLst>
            </p:cNvPr>
            <p:cNvGrpSpPr/>
            <p:nvPr/>
          </p:nvGrpSpPr>
          <p:grpSpPr>
            <a:xfrm>
              <a:off x="5521659" y="997690"/>
              <a:ext cx="1127232" cy="965988"/>
              <a:chOff x="14134684" y="1365619"/>
              <a:chExt cx="2816677" cy="2111764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B06DCD5-0D5D-45C4-BDE2-F7C396C5C50C}"/>
                  </a:ext>
                </a:extLst>
              </p:cNvPr>
              <p:cNvSpPr txBox="1"/>
              <p:nvPr/>
            </p:nvSpPr>
            <p:spPr>
              <a:xfrm>
                <a:off x="14134684" y="1365619"/>
                <a:ext cx="2816677" cy="437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unctional Categories</a:t>
                </a:r>
              </a:p>
            </p:txBody>
          </p:sp>
          <p:pic>
            <p:nvPicPr>
              <p:cNvPr id="35" name="Google Shape;1033;p14" descr="Timeline&#10;&#10;Description automatically generated with medium confidence">
                <a:extLst>
                  <a:ext uri="{FF2B5EF4-FFF2-40B4-BE49-F238E27FC236}">
                    <a16:creationId xmlns:a16="http://schemas.microsoft.com/office/drawing/2014/main" id="{95EB35B2-F882-49A8-B8CD-472205965413}"/>
                  </a:ext>
                </a:extLst>
              </p:cNvPr>
              <p:cNvPicPr preferRelativeResize="0"/>
              <p:nvPr/>
            </p:nvPicPr>
            <p:blipFill rotWithShape="1">
              <a:blip r:embed="rId5">
                <a:alphaModFix/>
              </a:blip>
              <a:srcRect l="76262" t="37278" r="20134" b="39328"/>
              <a:stretch/>
            </p:blipFill>
            <p:spPr>
              <a:xfrm>
                <a:off x="14388731" y="1762821"/>
                <a:ext cx="393644" cy="171456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6" name="Google Shape;1088;p14">
                <a:extLst>
                  <a:ext uri="{FF2B5EF4-FFF2-40B4-BE49-F238E27FC236}">
                    <a16:creationId xmlns:a16="http://schemas.microsoft.com/office/drawing/2014/main" id="{C09F2DFC-853E-4A0E-8B96-B6BB130DD067}"/>
                  </a:ext>
                </a:extLst>
              </p:cNvPr>
              <p:cNvSpPr txBox="1"/>
              <p:nvPr/>
            </p:nvSpPr>
            <p:spPr>
              <a:xfrm>
                <a:off x="14695703" y="1708177"/>
                <a:ext cx="2255658" cy="17483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06260" tIns="53116" rIns="106260" bIns="53116" anchor="t" anchorCtr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ea typeface="Calibri"/>
                    <a:cs typeface="Arial" panose="020B0604020202020204" pitchFamily="34" charset="0"/>
                    <a:sym typeface="Calibri"/>
                  </a:rPr>
                  <a:t>Cellular activitie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Cellular compartment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Cognitive function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HD pathology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Lipid Class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500" dirty="0">
                    <a:solidFill>
                      <a:schemeClr val="dk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Neuroprotection</a:t>
                </a:r>
                <a:endParaRPr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Google Shape;1082;p14">
              <a:extLst>
                <a:ext uri="{FF2B5EF4-FFF2-40B4-BE49-F238E27FC236}">
                  <a16:creationId xmlns:a16="http://schemas.microsoft.com/office/drawing/2014/main" id="{2E8E19EC-D404-4AB3-8459-B89D4C839472}"/>
                </a:ext>
              </a:extLst>
            </p:cNvPr>
            <p:cNvSpPr txBox="1"/>
            <p:nvPr/>
          </p:nvSpPr>
          <p:spPr>
            <a:xfrm>
              <a:off x="4770768" y="3743327"/>
              <a:ext cx="920420" cy="21499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Log</a:t>
              </a:r>
              <a:r>
                <a:rPr lang="en-US" sz="700" b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b="1" i="1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700" b="1" i="1" baseline="-250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j</a:t>
              </a:r>
              <a:r>
                <a:rPr lang="en-US" sz="700" b="1" i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700" b="1" i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r>
                <a:rPr lang="en-US" sz="700" b="1" i="1" baseline="-250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Google Shape;1069;p14">
              <a:extLst>
                <a:ext uri="{FF2B5EF4-FFF2-40B4-BE49-F238E27FC236}">
                  <a16:creationId xmlns:a16="http://schemas.microsoft.com/office/drawing/2014/main" id="{7772CF1C-D505-4691-832B-F4758C9164CC}"/>
                </a:ext>
              </a:extLst>
            </p:cNvPr>
            <p:cNvSpPr txBox="1"/>
            <p:nvPr/>
          </p:nvSpPr>
          <p:spPr>
            <a:xfrm>
              <a:off x="4400801" y="3590655"/>
              <a:ext cx="2103732" cy="184214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106260" tIns="53116" rIns="106260" bIns="53116" anchor="t" anchorCtr="0">
              <a:spAutoFit/>
            </a:bodyPr>
            <a:lstStyle/>
            <a:p>
              <a:r>
                <a:rPr lang="en-US" sz="500" b="1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0.0              0.5                1.0                 1.5               2.0                      </a:t>
              </a:r>
              <a:endParaRPr sz="5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F8B14F8-5DF4-45FA-9416-F1AF2EB97043}"/>
                </a:ext>
              </a:extLst>
            </p:cNvPr>
            <p:cNvSpPr txBox="1"/>
            <p:nvPr/>
          </p:nvSpPr>
          <p:spPr>
            <a:xfrm>
              <a:off x="3276816" y="-1825"/>
              <a:ext cx="247184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Google Shape;1200;p16">
              <a:extLst>
                <a:ext uri="{FF2B5EF4-FFF2-40B4-BE49-F238E27FC236}">
                  <a16:creationId xmlns:a16="http://schemas.microsoft.com/office/drawing/2014/main" id="{C6B54057-0463-457D-8EE6-F89BE6FB31BF}"/>
                </a:ext>
              </a:extLst>
            </p:cNvPr>
            <p:cNvCxnSpPr/>
            <p:nvPr/>
          </p:nvCxnSpPr>
          <p:spPr>
            <a:xfrm flipH="1">
              <a:off x="782107" y="466041"/>
              <a:ext cx="763140" cy="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32" name="Google Shape;473;p6">
              <a:extLst>
                <a:ext uri="{FF2B5EF4-FFF2-40B4-BE49-F238E27FC236}">
                  <a16:creationId xmlns:a16="http://schemas.microsoft.com/office/drawing/2014/main" id="{1C9FAC8F-DC02-4276-9FA5-B75985571AC8}"/>
                </a:ext>
              </a:extLst>
            </p:cNvPr>
            <p:cNvCxnSpPr>
              <a:endCxn id="5" idx="2"/>
            </p:cNvCxnSpPr>
            <p:nvPr/>
          </p:nvCxnSpPr>
          <p:spPr>
            <a:xfrm>
              <a:off x="3285214" y="9855"/>
              <a:ext cx="1391" cy="4104945"/>
            </a:xfrm>
            <a:prstGeom prst="straightConnector1">
              <a:avLst/>
            </a:prstGeom>
            <a:noFill/>
            <a:ln w="28575" cap="flat" cmpd="sng">
              <a:solidFill>
                <a:schemeClr val="bg1">
                  <a:lumMod val="50000"/>
                </a:schemeClr>
              </a:solidFill>
              <a:prstDash val="dash"/>
              <a:miter lim="800000"/>
              <a:headEnd type="none" w="sm" len="sm"/>
              <a:tailEnd type="none" w="sm" len="sm"/>
            </a:ln>
          </p:spPr>
        </p:cxnSp>
        <p:sp>
          <p:nvSpPr>
            <p:cNvPr id="33" name="Google Shape;1088;p14">
              <a:extLst>
                <a:ext uri="{FF2B5EF4-FFF2-40B4-BE49-F238E27FC236}">
                  <a16:creationId xmlns:a16="http://schemas.microsoft.com/office/drawing/2014/main" id="{10995C3D-3D38-4D7E-BE67-D4CC56610C9D}"/>
                </a:ext>
              </a:extLst>
            </p:cNvPr>
            <p:cNvSpPr txBox="1"/>
            <p:nvPr/>
          </p:nvSpPr>
          <p:spPr>
            <a:xfrm>
              <a:off x="3229265" y="1350"/>
              <a:ext cx="1292948" cy="363172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500" dirty="0">
                  <a:solidFill>
                    <a:schemeClr val="dk1"/>
                  </a:solidFill>
                  <a:latin typeface="Arial" panose="020B0604020202020204" pitchFamily="34" charset="0"/>
                  <a:ea typeface="Calibri"/>
                  <a:cs typeface="Arial" panose="020B0604020202020204" pitchFamily="34" charset="0"/>
                  <a:sym typeface="Calibri"/>
                </a:rPr>
                <a:t>Cell survival</a:t>
              </a: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xon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regeneratio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nit-inflammator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respons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ulfatid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oly-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unsaturated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fatt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cid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spatidylserin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phatidylinosito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eramid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phatidylinositol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phatidylglycerol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phatidylethanolamine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plasmalogen</a:t>
              </a: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phatidylethanolamin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hosphatidic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cid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yso-glycerophospho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Globosid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Gangliosid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eramide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ardiolipi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ynaptogenesi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Reduce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neuronal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excitoxicity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ro-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inflammator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ediator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Neurotransmitter release</a:t>
              </a: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yelination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f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neuron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embrane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fluidity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aintains lipid homeostasis</a:t>
              </a: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Increased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dendritic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pine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density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ER stress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rotectio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ER stress mediated cell death</a:t>
              </a: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Enhanced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hippocamp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neurogenesi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alcium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homeostasi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ctivation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f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BDNF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ignalling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ynaptic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lasticit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/LTP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inductio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ynaptic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Neuronal cell body lipids</a:t>
              </a: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yelin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yelin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fatt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c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itochondri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xon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xon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fatty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c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strocyte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Signal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transductio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itochondri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bioenergetic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Membrane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trafficking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nd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dynamic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 raft-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ssociated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ipids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el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proliferation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xon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growth</a:t>
              </a:r>
              <a:endParaRPr lang="de-DE" sz="5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  <a:p>
              <a:pPr lvl="0" algn="r"/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Axon-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glial</a:t>
              </a:r>
              <a:r>
                <a:rPr lang="de-DE" sz="500" dirty="0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 </a:t>
              </a:r>
              <a:r>
                <a:rPr lang="de-DE" sz="500" dirty="0" err="1">
                  <a:solidFill>
                    <a:schemeClr val="dk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interaction</a:t>
              </a:r>
              <a:endParaRPr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877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86</Words>
  <Application>Microsoft Office PowerPoint</Application>
  <PresentationFormat>Custom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heen Farzana</dc:creator>
  <cp:lastModifiedBy>Farheen Farzana</cp:lastModifiedBy>
  <cp:revision>3</cp:revision>
  <dcterms:created xsi:type="dcterms:W3CDTF">2022-04-16T06:23:37Z</dcterms:created>
  <dcterms:modified xsi:type="dcterms:W3CDTF">2022-04-18T01:59:39Z</dcterms:modified>
</cp:coreProperties>
</file>